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png" ContentType="image/png"/>
  <Override PartName="/ppt/media/image6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E302E6-4242-454A-B044-F1F1B97C97CE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34AB28-D550-44B3-9F5E-BD4FEE5D8E9B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DAB637-2855-4B4D-9BFF-BE0FFE5A3D5D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TW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BAA328-302C-4A95-AFAE-4F014579F5F5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0A2DF3-AF02-4C8A-9698-77818F8D19C9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1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投影片編號版面配置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C46604-D18F-4E86-9FF7-1674FB27AA52}" type="slidenum">
              <a:rPr b="0" lang="zh-TW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C5DB64-3709-4070-BC07-29D67CCB1A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AD277-5FF9-47BB-A9F9-EDE6D9B5C8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06472A-0AB4-4B1B-AB17-233C74CC2A8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48D477-06A5-4331-BF65-B8679CA44E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1F7BE-591F-4BEF-8558-CFA2280A75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86A2D-C7EF-40DB-8D08-25358CDF9BC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91358-F769-453A-8360-A025DEF33B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453FD8-DBB7-4DD5-A941-7E42EAAC30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E7BEB1-B891-4AD1-B10E-020BD188C9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9AF94-7458-458E-AA9C-94C0C44904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7F756-A58C-48C1-9473-4555EEE441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E2827-418C-4200-8727-41A3C6CD6A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F255482-11AA-46DF-8799-ACB9441D73D1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" descr=""/>
          <p:cNvPicPr/>
          <p:nvPr/>
        </p:nvPicPr>
        <p:blipFill>
          <a:blip r:embed="rId1"/>
          <a:srcRect l="11424" t="23427" r="5945" b="14440"/>
          <a:stretch/>
        </p:blipFill>
        <p:spPr>
          <a:xfrm>
            <a:off x="0" y="617400"/>
            <a:ext cx="9144000" cy="3891240"/>
          </a:xfrm>
          <a:prstGeom prst="rect">
            <a:avLst/>
          </a:prstGeom>
          <a:ln w="0">
            <a:noFill/>
          </a:ln>
        </p:spPr>
      </p:pic>
      <p:sp>
        <p:nvSpPr>
          <p:cNvPr id="49" name="文字方塊 6"/>
          <p:cNvSpPr/>
          <p:nvPr/>
        </p:nvSpPr>
        <p:spPr>
          <a:xfrm>
            <a:off x="257400" y="1080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字方塊 6"/>
          <p:cNvSpPr/>
          <p:nvPr/>
        </p:nvSpPr>
        <p:spPr>
          <a:xfrm>
            <a:off x="684360" y="4653000"/>
            <a:ext cx="777708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arch results of single nucleotide polymorphism (SNP) of rs466013 of the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used in this study (http://www.ncbi.nlm.nih.gov/projects/SNP/snp_ref.cgi?rs=466013). Above: Genomic location of rs466013 (pointed by red arrows; the NCBI Assembly database: GRCh37.p10 version). Down: Genomic location of rs466013 for 6 versions of the NCBI Assembly database (pointed by red arrows)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" name="直線單箭頭接點 9"/>
          <p:cNvCxnSpPr/>
          <p:nvPr/>
        </p:nvCxnSpPr>
        <p:spPr>
          <a:xfrm flipH="1">
            <a:off x="7771680" y="104724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2" name="直線單箭頭接點 11"/>
          <p:cNvCxnSpPr/>
          <p:nvPr/>
        </p:nvCxnSpPr>
        <p:spPr>
          <a:xfrm flipH="1">
            <a:off x="2431440" y="150300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3" name="直線單箭頭接點 12"/>
          <p:cNvCxnSpPr/>
          <p:nvPr/>
        </p:nvCxnSpPr>
        <p:spPr>
          <a:xfrm flipH="1">
            <a:off x="1402560" y="344448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4" name="直線單箭頭接點 13"/>
          <p:cNvCxnSpPr/>
          <p:nvPr/>
        </p:nvCxnSpPr>
        <p:spPr>
          <a:xfrm flipH="1">
            <a:off x="1402560" y="368280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5" name="直線單箭頭接點 14"/>
          <p:cNvCxnSpPr/>
          <p:nvPr/>
        </p:nvCxnSpPr>
        <p:spPr>
          <a:xfrm flipH="1">
            <a:off x="1402560" y="386028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6" name="直線單箭頭接點 15"/>
          <p:cNvCxnSpPr/>
          <p:nvPr/>
        </p:nvCxnSpPr>
        <p:spPr>
          <a:xfrm flipH="1">
            <a:off x="1402560" y="404316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7" name="直線單箭頭接點 16"/>
          <p:cNvCxnSpPr/>
          <p:nvPr/>
        </p:nvCxnSpPr>
        <p:spPr>
          <a:xfrm flipH="1">
            <a:off x="1402560" y="422064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58" name="直線單箭頭接點 17"/>
          <p:cNvCxnSpPr/>
          <p:nvPr/>
        </p:nvCxnSpPr>
        <p:spPr>
          <a:xfrm flipH="1">
            <a:off x="1402560" y="4387320"/>
            <a:ext cx="36108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9" name="Picture 6" descr=""/>
          <p:cNvPicPr/>
          <p:nvPr/>
        </p:nvPicPr>
        <p:blipFill>
          <a:blip r:embed="rId1"/>
          <a:srcRect l="2634" t="18245" r="2429" b="21688"/>
          <a:stretch/>
        </p:blipFill>
        <p:spPr>
          <a:xfrm>
            <a:off x="0" y="620640"/>
            <a:ext cx="9144000" cy="3273480"/>
          </a:xfrm>
          <a:prstGeom prst="rect">
            <a:avLst/>
          </a:prstGeom>
          <a:ln w="0">
            <a:noFill/>
          </a:ln>
        </p:spPr>
      </p:pic>
      <p:sp>
        <p:nvSpPr>
          <p:cNvPr id="60" name="文字方塊 7"/>
          <p:cNvSpPr/>
          <p:nvPr/>
        </p:nvSpPr>
        <p:spPr>
          <a:xfrm>
            <a:off x="454320" y="1890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1" name="直線單箭頭接點 9"/>
          <p:cNvCxnSpPr/>
          <p:nvPr/>
        </p:nvCxnSpPr>
        <p:spPr>
          <a:xfrm>
            <a:off x="117360" y="3115800"/>
            <a:ext cx="216720" cy="1836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2" name="直線單箭頭接點 12"/>
          <p:cNvCxnSpPr/>
          <p:nvPr/>
        </p:nvCxnSpPr>
        <p:spPr>
          <a:xfrm flipH="1">
            <a:off x="1979280" y="2781000"/>
            <a:ext cx="144720" cy="16092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3" name="直線單箭頭接點 14"/>
          <p:cNvCxnSpPr/>
          <p:nvPr/>
        </p:nvCxnSpPr>
        <p:spPr>
          <a:xfrm flipH="1">
            <a:off x="4419000" y="3131640"/>
            <a:ext cx="216360" cy="108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cxnSp>
        <p:nvCxnSpPr>
          <p:cNvPr id="64" name="直線單箭頭接點 16"/>
          <p:cNvCxnSpPr/>
          <p:nvPr/>
        </p:nvCxnSpPr>
        <p:spPr>
          <a:xfrm>
            <a:off x="9035640" y="2868480"/>
            <a:ext cx="1080" cy="216720"/>
          </a:xfrm>
          <a:prstGeom prst="straightConnector1">
            <a:avLst/>
          </a:prstGeom>
          <a:ln w="3168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65" name="文字方塊 6"/>
          <p:cNvSpPr/>
          <p:nvPr/>
        </p:nvSpPr>
        <p:spPr>
          <a:xfrm>
            <a:off x="755640" y="4149720"/>
            <a:ext cx="777708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arch results of single nucleotide polymorphisms (SNPs) of rs466013, rs425507, rs388700 and rs402280 of the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used in this study (http://genome.ucsc.edu/cgi-bin/hgTracks?db=hg18&amp;position=chr21%3A30120300-30129700&amp;hgsid=370279953_3haDCdtlwLEpPqkcmUFYdaAFYNhx). Above: Genomic location of the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. Down: Genomic location of rs466013, rs425507, rs388700 and rs402280 (pointed by red arrows; the NCBI Assembly database: NCBI36/hg18 version)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6" name="Object 2"/>
          <p:cNvGraphicFramePr/>
          <p:nvPr/>
        </p:nvGraphicFramePr>
        <p:xfrm>
          <a:off x="704880" y="631800"/>
          <a:ext cx="3579840" cy="3373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7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4880" y="631800"/>
                    <a:ext cx="3579840" cy="3373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8" name="文字方塊 3"/>
          <p:cNvSpPr/>
          <p:nvPr/>
        </p:nvSpPr>
        <p:spPr>
          <a:xfrm>
            <a:off x="762120" y="10800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文字方塊 6"/>
          <p:cNvSpPr/>
          <p:nvPr/>
        </p:nvSpPr>
        <p:spPr>
          <a:xfrm>
            <a:off x="684360" y="4005360"/>
            <a:ext cx="777708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RNA expression levels in peripheral blood mononuclear cells according to the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NPs (rs388700 and rs402280) genotypes. The relative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expression was detected by </a:t>
            </a:r>
            <a:r>
              <a:rPr b="0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quantitative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eal-time RT-PCR, and expression from individuals with TT+TA genotypes was compared to that from individuals with AA genotype. </a:t>
            </a:r>
            <a:r>
              <a:rPr b="0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The </a:t>
            </a:r>
            <a:r>
              <a:rPr b="0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GRIK1</a:t>
            </a:r>
            <a:r>
              <a:rPr b="0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 (NM_000830.3) primer sequences were 5’-gcggttagagatggatcaaca-3’ (located at nucleotide 2559-2579 of the transcript (NM_000830.3) and 5’-tcatgaaagcccacatcttct-3’ (located at nucleotide 2617-2637 of the transcript (NM_000830.3))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relative expression levels were expressed as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RIK1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RNA/ </a:t>
            </a:r>
            <a:r>
              <a:rPr b="0" i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PRT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mRNA ratio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0" name="Object 6"/>
          <p:cNvGraphicFramePr/>
          <p:nvPr/>
        </p:nvGraphicFramePr>
        <p:xfrm>
          <a:off x="4572000" y="620640"/>
          <a:ext cx="3579840" cy="337356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1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572000" y="620640"/>
                    <a:ext cx="3579840" cy="3373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文字方塊 3"/>
          <p:cNvSpPr/>
          <p:nvPr/>
        </p:nvSpPr>
        <p:spPr>
          <a:xfrm>
            <a:off x="257400" y="44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圖片 5" descr="未命名.png"/>
          <p:cNvPicPr/>
          <p:nvPr/>
        </p:nvPicPr>
        <p:blipFill>
          <a:blip r:embed="rId1"/>
          <a:srcRect l="652" t="12203" r="3803" b="17452"/>
          <a:stretch/>
        </p:blipFill>
        <p:spPr>
          <a:xfrm>
            <a:off x="1979640" y="1541520"/>
            <a:ext cx="4654440" cy="3427200"/>
          </a:xfrm>
          <a:prstGeom prst="rect">
            <a:avLst/>
          </a:prstGeom>
          <a:ln w="0">
            <a:noFill/>
          </a:ln>
        </p:spPr>
      </p:pic>
      <p:sp>
        <p:nvSpPr>
          <p:cNvPr id="74" name="文字方塊 2"/>
          <p:cNvSpPr/>
          <p:nvPr/>
        </p:nvSpPr>
        <p:spPr>
          <a:xfrm>
            <a:off x="1552680" y="1612800"/>
            <a:ext cx="12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uropea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文字方塊 3"/>
          <p:cNvSpPr/>
          <p:nvPr/>
        </p:nvSpPr>
        <p:spPr>
          <a:xfrm>
            <a:off x="2849040" y="1252440"/>
            <a:ext cx="12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Europea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文字方塊 6"/>
          <p:cNvSpPr/>
          <p:nvPr/>
        </p:nvSpPr>
        <p:spPr>
          <a:xfrm>
            <a:off x="4579560" y="1252440"/>
            <a:ext cx="122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Japanes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文字方塊 7"/>
          <p:cNvSpPr/>
          <p:nvPr/>
        </p:nvSpPr>
        <p:spPr>
          <a:xfrm>
            <a:off x="5649480" y="1685880"/>
            <a:ext cx="136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Taiwanes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8" name="直線單箭頭接點 7"/>
          <p:cNvCxnSpPr/>
          <p:nvPr/>
        </p:nvCxnSpPr>
        <p:spPr>
          <a:xfrm flipH="1">
            <a:off x="3058560" y="4349520"/>
            <a:ext cx="937080" cy="648360"/>
          </a:xfrm>
          <a:prstGeom prst="straightConnector1">
            <a:avLst/>
          </a:prstGeom>
          <a:ln w="414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9" name="文字方塊 10"/>
          <p:cNvSpPr/>
          <p:nvPr/>
        </p:nvSpPr>
        <p:spPr>
          <a:xfrm>
            <a:off x="10440" y="5141880"/>
            <a:ext cx="50605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mon elements in "Khor CC", "Onouchi Y" and "Lee YC"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2233152 (MI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文字方塊 11"/>
          <p:cNvSpPr/>
          <p:nvPr/>
        </p:nvSpPr>
        <p:spPr>
          <a:xfrm>
            <a:off x="5068800" y="4608360"/>
            <a:ext cx="406692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mon elements in "Onouchi Y" and "Lee YC"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2736340 (BL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2618479 (BL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6993775 (BL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10401344 (ITPK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4813003 (CD4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1" name="直線單箭頭接點 10"/>
          <p:cNvCxnSpPr/>
          <p:nvPr/>
        </p:nvCxnSpPr>
        <p:spPr>
          <a:xfrm>
            <a:off x="5363640" y="2836800"/>
            <a:ext cx="1080360" cy="1745280"/>
          </a:xfrm>
          <a:prstGeom prst="straightConnector1">
            <a:avLst/>
          </a:prstGeom>
          <a:ln w="414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2" name="直線接點 11"/>
          <p:cNvSpPr/>
          <p:nvPr/>
        </p:nvSpPr>
        <p:spPr>
          <a:xfrm>
            <a:off x="1403280" y="1109520"/>
            <a:ext cx="2737080" cy="0"/>
          </a:xfrm>
          <a:prstGeom prst="line">
            <a:avLst/>
          </a:prstGeom>
          <a:ln w="41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字方塊 16"/>
          <p:cNvSpPr/>
          <p:nvPr/>
        </p:nvSpPr>
        <p:spPr>
          <a:xfrm>
            <a:off x="1590840" y="344520"/>
            <a:ext cx="232488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uropean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線接點 13"/>
          <p:cNvSpPr/>
          <p:nvPr/>
        </p:nvSpPr>
        <p:spPr>
          <a:xfrm>
            <a:off x="4643280" y="1109520"/>
            <a:ext cx="2737080" cy="0"/>
          </a:xfrm>
          <a:prstGeom prst="line">
            <a:avLst/>
          </a:prstGeom>
          <a:ln w="41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字方塊 18"/>
          <p:cNvSpPr/>
          <p:nvPr/>
        </p:nvSpPr>
        <p:spPr>
          <a:xfrm>
            <a:off x="5372640" y="333360"/>
            <a:ext cx="142272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ian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文字方塊 6"/>
          <p:cNvSpPr/>
          <p:nvPr/>
        </p:nvSpPr>
        <p:spPr>
          <a:xfrm>
            <a:off x="684360" y="5877000"/>
            <a:ext cx="77770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n diagram of 4 GWAS studies. Gene SNPs from 4 GWAS studies were used for searching for common gene SNPs by using Venny website (http://bioinfogp.cnb.csic.es/tools/venny/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文字方塊 3"/>
          <p:cNvSpPr/>
          <p:nvPr/>
        </p:nvSpPr>
        <p:spPr>
          <a:xfrm>
            <a:off x="257400" y="44280"/>
            <a:ext cx="122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8" name="圖片 1" descr="未命名.png"/>
          <p:cNvPicPr/>
          <p:nvPr/>
        </p:nvPicPr>
        <p:blipFill>
          <a:blip r:embed="rId1"/>
          <a:srcRect l="652" t="12203" r="3803" b="17452"/>
          <a:stretch/>
        </p:blipFill>
        <p:spPr>
          <a:xfrm>
            <a:off x="2195640" y="907920"/>
            <a:ext cx="4680000" cy="3446640"/>
          </a:xfrm>
          <a:prstGeom prst="rect">
            <a:avLst/>
          </a:prstGeom>
          <a:ln w="0">
            <a:noFill/>
          </a:ln>
        </p:spPr>
      </p:pic>
      <p:sp>
        <p:nvSpPr>
          <p:cNvPr id="89" name="文字方塊 2"/>
          <p:cNvSpPr/>
          <p:nvPr/>
        </p:nvSpPr>
        <p:spPr>
          <a:xfrm>
            <a:off x="1914840" y="1052640"/>
            <a:ext cx="122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Japanes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文字方塊 3"/>
          <p:cNvSpPr/>
          <p:nvPr/>
        </p:nvSpPr>
        <p:spPr>
          <a:xfrm>
            <a:off x="3057120" y="692280"/>
            <a:ext cx="136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Taiwanes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文字方塊 4"/>
          <p:cNvSpPr/>
          <p:nvPr/>
        </p:nvSpPr>
        <p:spPr>
          <a:xfrm>
            <a:off x="4785120" y="682560"/>
            <a:ext cx="1361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Taiwanese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文字方塊 5"/>
          <p:cNvSpPr/>
          <p:nvPr/>
        </p:nvSpPr>
        <p:spPr>
          <a:xfrm>
            <a:off x="5883840" y="1042920"/>
            <a:ext cx="107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Korean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3" name="直線單箭頭接點 7"/>
          <p:cNvCxnSpPr/>
          <p:nvPr/>
        </p:nvCxnSpPr>
        <p:spPr>
          <a:xfrm flipH="1">
            <a:off x="1763280" y="2133360"/>
            <a:ext cx="1656720" cy="1872360"/>
          </a:xfrm>
          <a:prstGeom prst="straightConnector1">
            <a:avLst/>
          </a:prstGeom>
          <a:ln w="414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4" name="文字方塊 8"/>
          <p:cNvSpPr/>
          <p:nvPr/>
        </p:nvSpPr>
        <p:spPr>
          <a:xfrm>
            <a:off x="255600" y="4221000"/>
            <a:ext cx="4111200" cy="179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mon elements in "Onouchi Y " and "Lee YC"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2736340 (BL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2618479</a:t>
            </a:r>
            <a:r>
              <a:rPr b="1" lang="zh-TW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L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6993775 (BLK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10401344 (ITPKC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2233152 (MIA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4813003 (CD4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5" name="直線單箭頭接點 9"/>
          <p:cNvCxnSpPr>
            <a:endCxn id="96" idx="0"/>
          </p:cNvCxnSpPr>
          <p:nvPr/>
        </p:nvCxnSpPr>
        <p:spPr>
          <a:xfrm>
            <a:off x="4788000" y="2133720"/>
            <a:ext cx="1945440" cy="2088000"/>
          </a:xfrm>
          <a:prstGeom prst="straightConnector1">
            <a:avLst/>
          </a:prstGeom>
          <a:ln w="4140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6" name="文字方塊 13"/>
          <p:cNvSpPr/>
          <p:nvPr/>
        </p:nvSpPr>
        <p:spPr>
          <a:xfrm>
            <a:off x="4827960" y="4221000"/>
            <a:ext cx="3810960" cy="137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mon elements in "Lee YC" and "Tsai FJ"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4894410 (MRPS2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1873668 (MRPS2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4243399 (COPB2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s1568657 (BTBD1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文字方塊 17"/>
          <p:cNvSpPr/>
          <p:nvPr/>
        </p:nvSpPr>
        <p:spPr>
          <a:xfrm>
            <a:off x="3859920" y="-87480"/>
            <a:ext cx="142272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4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ian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直線接點 12"/>
          <p:cNvSpPr/>
          <p:nvPr/>
        </p:nvSpPr>
        <p:spPr>
          <a:xfrm>
            <a:off x="1979640" y="549360"/>
            <a:ext cx="4968720" cy="0"/>
          </a:xfrm>
          <a:prstGeom prst="line">
            <a:avLst/>
          </a:prstGeom>
          <a:ln w="41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文字方塊 6"/>
          <p:cNvSpPr/>
          <p:nvPr/>
        </p:nvSpPr>
        <p:spPr>
          <a:xfrm>
            <a:off x="684360" y="5877000"/>
            <a:ext cx="77770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.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enn diagram of 4 GWAS studies. Gene SNPs from 4 GWAS studies were used for searching for common gene SNPs by using Venny website (http://bioinfogp.cnb.csic.es/tools/venny/)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16T09:02:30Z</dcterms:created>
  <dc:creator>TB</dc:creator>
  <dc:description/>
  <dc:language>en-US</dc:language>
  <cp:lastModifiedBy>TB</cp:lastModifiedBy>
  <dcterms:modified xsi:type="dcterms:W3CDTF">2014-08-28T03:57:31Z</dcterms:modified>
  <cp:revision>70</cp:revision>
  <dc:subject/>
  <dc:title>投影片 1</dc:title>
</cp:coreProperties>
</file>